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6" d="100"/>
          <a:sy n="96" d="100"/>
        </p:scale>
        <p:origin x="-1164" y="165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0D9E8-1D70-4EAD-B25D-85C1F0E7839F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322136-4096-4EDB-920A-A9191A3219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09021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0D9E8-1D70-4EAD-B25D-85C1F0E7839F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322136-4096-4EDB-920A-A9191A3219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07686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0D9E8-1D70-4EAD-B25D-85C1F0E7839F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322136-4096-4EDB-920A-A9191A3219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72101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0D9E8-1D70-4EAD-B25D-85C1F0E7839F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322136-4096-4EDB-920A-A9191A3219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8743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0D9E8-1D70-4EAD-B25D-85C1F0E7839F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322136-4096-4EDB-920A-A9191A3219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4263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0D9E8-1D70-4EAD-B25D-85C1F0E7839F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322136-4096-4EDB-920A-A9191A3219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86795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0D9E8-1D70-4EAD-B25D-85C1F0E7839F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322136-4096-4EDB-920A-A9191A3219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22216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0D9E8-1D70-4EAD-B25D-85C1F0E7839F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322136-4096-4EDB-920A-A9191A3219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61361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0D9E8-1D70-4EAD-B25D-85C1F0E7839F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322136-4096-4EDB-920A-A9191A3219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828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0D9E8-1D70-4EAD-B25D-85C1F0E7839F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322136-4096-4EDB-920A-A9191A3219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02236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0D9E8-1D70-4EAD-B25D-85C1F0E7839F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322136-4096-4EDB-920A-A9191A3219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1842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00D9E8-1D70-4EAD-B25D-85C1F0E7839F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322136-4096-4EDB-920A-A9191A3219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61680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10.png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12" Type="http://schemas.openxmlformats.org/officeDocument/2006/relationships/image" Target="../media/image9.png"/><Relationship Id="rId17" Type="http://schemas.openxmlformats.org/officeDocument/2006/relationships/image" Target="../media/image14.png"/><Relationship Id="rId2" Type="http://schemas.openxmlformats.org/officeDocument/2006/relationships/image" Target="../media/image1.png"/><Relationship Id="rId16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openxmlformats.org/officeDocument/2006/relationships/image" Target="../media/image8.png"/><Relationship Id="rId5" Type="http://schemas.microsoft.com/office/2007/relationships/hdphoto" Target="../media/hdphoto2.wdp"/><Relationship Id="rId15" Type="http://schemas.openxmlformats.org/officeDocument/2006/relationships/image" Target="../media/image12.png"/><Relationship Id="rId10" Type="http://schemas.openxmlformats.org/officeDocument/2006/relationships/image" Target="../media/image7.png"/><Relationship Id="rId4" Type="http://schemas.openxmlformats.org/officeDocument/2006/relationships/image" Target="../media/image2.png"/><Relationship Id="rId9" Type="http://schemas.openxmlformats.org/officeDocument/2006/relationships/image" Target="../media/image6.png"/><Relationship Id="rId1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 noChangeAspect="1" noChangeArrowheads="1"/>
          </p:cNvPicPr>
          <p:nvPr/>
        </p:nvPicPr>
        <p:blipFill>
          <a:blip r:embed="rId2" cstate="print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1487542" y="469845"/>
            <a:ext cx="1142999" cy="17954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4" cstate="print">
            <a:grayscl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266755" y="479369"/>
            <a:ext cx="1154112" cy="1785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TextBox 5"/>
          <p:cNvSpPr txBox="1"/>
          <p:nvPr/>
        </p:nvSpPr>
        <p:spPr>
          <a:xfrm>
            <a:off x="2621017" y="531757"/>
            <a:ext cx="685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Contro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611491" y="846082"/>
            <a:ext cx="9239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0.01µg/m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611492" y="1142999"/>
            <a:ext cx="750834" cy="2138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0.1µg/m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621016" y="1417582"/>
            <a:ext cx="9239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1µg/m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621016" y="1704975"/>
            <a:ext cx="7603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10µg/m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621016" y="2008132"/>
            <a:ext cx="9239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100µg/m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AutoShape 149"/>
          <p:cNvSpPr>
            <a:spLocks noChangeArrowheads="1"/>
          </p:cNvSpPr>
          <p:nvPr/>
        </p:nvSpPr>
        <p:spPr bwMode="auto">
          <a:xfrm>
            <a:off x="268342" y="341257"/>
            <a:ext cx="1133475" cy="104775"/>
          </a:xfrm>
          <a:prstGeom prst="rtTriangle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sv-SE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AutoShape 149"/>
          <p:cNvSpPr>
            <a:spLocks noChangeArrowheads="1"/>
          </p:cNvSpPr>
          <p:nvPr/>
        </p:nvSpPr>
        <p:spPr bwMode="auto">
          <a:xfrm>
            <a:off x="1487542" y="341257"/>
            <a:ext cx="1133475" cy="104775"/>
          </a:xfrm>
          <a:prstGeom prst="rtTriangle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sv-SE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335810" y="549674"/>
            <a:ext cx="762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Contro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335810" y="848054"/>
            <a:ext cx="11175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Phleo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 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10</a:t>
            </a:r>
            <a:r>
              <a:rPr lang="el-GR" sz="800" b="1" dirty="0" smtClean="0">
                <a:latin typeface="Arial" panose="020B0604020202020204" pitchFamily="34" charset="0"/>
                <a:cs typeface="Arial" pitchFamily="34" charset="0"/>
              </a:rPr>
              <a:t>μ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g/m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335810" y="1147270"/>
            <a:ext cx="10455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Phleo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+ 0.6M </a:t>
            </a:r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KCl</a:t>
            </a:r>
            <a:endParaRPr lang="sv-SE" sz="800" b="1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335810" y="1469146"/>
            <a:ext cx="762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Contro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335810" y="1774935"/>
            <a:ext cx="10455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Phleo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 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10</a:t>
            </a:r>
            <a:r>
              <a:rPr lang="el-GR" sz="800" b="1" dirty="0" smtClean="0">
                <a:latin typeface="Arial" panose="020B0604020202020204" pitchFamily="34" charset="0"/>
                <a:cs typeface="Arial" pitchFamily="34" charset="0"/>
              </a:rPr>
              <a:t>μ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g/m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335810" y="2076122"/>
            <a:ext cx="11175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Phleo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+ 0.6M </a:t>
            </a:r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KCl</a:t>
            </a:r>
            <a:endParaRPr lang="sv-SE" sz="800" b="1" baseline="-250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0" name="Picture 11"/>
          <p:cNvPicPr>
            <a:picLocks noChangeAspect="1" noChangeArrowheads="1"/>
          </p:cNvPicPr>
          <p:nvPr/>
        </p:nvPicPr>
        <p:blipFill>
          <a:blip r:embed="rId6" cstate="print">
            <a:grayscl/>
            <a:lum bright="28000" contrast="67000"/>
          </a:blip>
          <a:srcRect/>
          <a:stretch>
            <a:fillRect/>
          </a:stretch>
        </p:blipFill>
        <p:spPr bwMode="auto">
          <a:xfrm>
            <a:off x="4161995" y="505176"/>
            <a:ext cx="1199757" cy="9038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1" name="Picture 12"/>
          <p:cNvPicPr>
            <a:picLocks noChangeAspect="1" noChangeArrowheads="1"/>
          </p:cNvPicPr>
          <p:nvPr/>
        </p:nvPicPr>
        <p:blipFill>
          <a:blip r:embed="rId7" cstate="print">
            <a:grayscl/>
            <a:lum bright="28000" contrast="67000"/>
          </a:blip>
          <a:srcRect/>
          <a:stretch>
            <a:fillRect/>
          </a:stretch>
        </p:blipFill>
        <p:spPr bwMode="auto">
          <a:xfrm>
            <a:off x="4161996" y="1443326"/>
            <a:ext cx="1199758" cy="9038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2" name="TextBox 21"/>
          <p:cNvSpPr txBox="1"/>
          <p:nvPr/>
        </p:nvSpPr>
        <p:spPr>
          <a:xfrm rot="16200000">
            <a:off x="3776771" y="1830440"/>
            <a:ext cx="6096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i="1" dirty="0" smtClean="0">
                <a:latin typeface="Arial" pitchFamily="34" charset="0"/>
                <a:cs typeface="Arial" pitchFamily="34" charset="0"/>
              </a:rPr>
              <a:t>sod2</a:t>
            </a:r>
            <a:r>
              <a:rPr lang="el-GR" sz="800" b="1" i="1" dirty="0" smtClean="0">
                <a:latin typeface="Arial" pitchFamily="34" charset="0"/>
                <a:cs typeface="Arial" pitchFamily="34" charset="0"/>
              </a:rPr>
              <a:t>Δ</a:t>
            </a:r>
            <a:endParaRPr lang="sv-SE" sz="8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 rot="16200000">
            <a:off x="3767245" y="883876"/>
            <a:ext cx="6096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i="1" dirty="0" smtClean="0">
                <a:latin typeface="Arial" panose="020B0604020202020204" pitchFamily="34" charset="0"/>
                <a:cs typeface="Arial" pitchFamily="34" charset="0"/>
              </a:rPr>
              <a:t>wt</a:t>
            </a:r>
            <a:endParaRPr lang="sv-SE" sz="8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409418" y="2276767"/>
            <a:ext cx="762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i="1" dirty="0" smtClean="0">
                <a:latin typeface="Arial" pitchFamily="34" charset="0"/>
                <a:cs typeface="Arial" pitchFamily="34" charset="0"/>
              </a:rPr>
              <a:t>wt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638143" y="2276767"/>
            <a:ext cx="762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i="1" dirty="0" smtClean="0">
                <a:latin typeface="Arial" pitchFamily="34" charset="0"/>
                <a:cs typeface="Arial" pitchFamily="34" charset="0"/>
              </a:rPr>
              <a:t>sty1</a:t>
            </a:r>
            <a:r>
              <a:rPr lang="el-GR" sz="800" b="1" dirty="0" smtClean="0">
                <a:latin typeface="Arial" pitchFamily="34" charset="0"/>
                <a:cs typeface="Arial" pitchFamily="34" charset="0"/>
              </a:rPr>
              <a:t>Δ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6" name="Picture 9"/>
          <p:cNvPicPr>
            <a:picLocks noChangeAspect="1" noChangeArrowheads="1"/>
          </p:cNvPicPr>
          <p:nvPr/>
        </p:nvPicPr>
        <p:blipFill>
          <a:blip r:embed="rId8" cstate="print">
            <a:grayscl/>
            <a:lum bright="16000" contrast="37000"/>
          </a:blip>
          <a:srcRect/>
          <a:stretch>
            <a:fillRect/>
          </a:stretch>
        </p:blipFill>
        <p:spPr bwMode="auto">
          <a:xfrm>
            <a:off x="322263" y="3278845"/>
            <a:ext cx="1222375" cy="854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7" name="TextBox 26"/>
          <p:cNvSpPr txBox="1"/>
          <p:nvPr/>
        </p:nvSpPr>
        <p:spPr>
          <a:xfrm>
            <a:off x="1541530" y="3311924"/>
            <a:ext cx="762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Contro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541530" y="3571875"/>
            <a:ext cx="9513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Phleo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 10</a:t>
            </a:r>
            <a:r>
              <a:rPr lang="el-GR" sz="800" b="1" dirty="0" smtClean="0">
                <a:latin typeface="Arial" panose="020B0604020202020204" pitchFamily="34" charset="0"/>
                <a:cs typeface="Arial" pitchFamily="34" charset="0"/>
              </a:rPr>
              <a:t>μ</a:t>
            </a:r>
            <a:r>
              <a:rPr lang="sv-SE" sz="800" b="1" smtClean="0">
                <a:latin typeface="Arial" panose="020B0604020202020204" pitchFamily="34" charset="0"/>
                <a:cs typeface="Arial" pitchFamily="34" charset="0"/>
              </a:rPr>
              <a:t>g/m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541530" y="3895725"/>
            <a:ext cx="10233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Phleo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+ 0.6M </a:t>
            </a:r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KCl</a:t>
            </a:r>
            <a:endParaRPr lang="sv-SE" sz="800" b="1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AutoShape 149"/>
          <p:cNvSpPr>
            <a:spLocks noChangeArrowheads="1"/>
          </p:cNvSpPr>
          <p:nvPr/>
        </p:nvSpPr>
        <p:spPr bwMode="auto">
          <a:xfrm>
            <a:off x="321768" y="3086100"/>
            <a:ext cx="1183182" cy="144100"/>
          </a:xfrm>
          <a:prstGeom prst="rtTriangle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sv-SE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Picture 3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2929483" y="2915815"/>
            <a:ext cx="1141411" cy="1089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2" name="Picture 4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2929483" y="4020716"/>
            <a:ext cx="1141412" cy="1089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3" name="Picture 5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4110584" y="2915815"/>
            <a:ext cx="1150936" cy="1089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4" name="Picture 6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4110583" y="4020716"/>
            <a:ext cx="1150937" cy="1089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5" name="Picture 7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5301208" y="2915816"/>
            <a:ext cx="1150937" cy="1089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6" name="Picture 8"/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5301208" y="4020715"/>
            <a:ext cx="1150937" cy="1089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7" name="TextBox 36"/>
          <p:cNvSpPr txBox="1"/>
          <p:nvPr/>
        </p:nvSpPr>
        <p:spPr>
          <a:xfrm>
            <a:off x="3130514" y="2677433"/>
            <a:ext cx="762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smtClean="0">
                <a:latin typeface="Arial" pitchFamily="34" charset="0"/>
                <a:cs typeface="Arial" pitchFamily="34" charset="0"/>
              </a:rPr>
              <a:t>Contro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4261855" y="2677433"/>
            <a:ext cx="9429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smtClean="0">
                <a:latin typeface="Arial" pitchFamily="34" charset="0"/>
                <a:cs typeface="Arial" pitchFamily="34" charset="0"/>
              </a:rPr>
              <a:t>Phleomycin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5212374" y="2677433"/>
            <a:ext cx="14001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smtClean="0">
                <a:latin typeface="Arial" pitchFamily="34" charset="0"/>
                <a:cs typeface="Arial" pitchFamily="34" charset="0"/>
              </a:rPr>
              <a:t>Phleomycin+ KCl</a:t>
            </a:r>
            <a:endParaRPr lang="sv-SE" sz="800" b="1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 rot="16200000">
            <a:off x="-84591" y="3589045"/>
            <a:ext cx="6096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i="1" dirty="0" smtClean="0">
                <a:latin typeface="Arial" pitchFamily="34" charset="0"/>
                <a:cs typeface="Arial" pitchFamily="34" charset="0"/>
              </a:rPr>
              <a:t>pzh1</a:t>
            </a:r>
            <a:r>
              <a:rPr lang="el-GR" sz="800" b="1" i="1" dirty="0" smtClean="0">
                <a:latin typeface="Arial" pitchFamily="34" charset="0"/>
                <a:cs typeface="Arial" pitchFamily="34" charset="0"/>
              </a:rPr>
              <a:t>Δ</a:t>
            </a:r>
            <a:endParaRPr lang="sv-SE" sz="8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2932313" y="5101293"/>
            <a:ext cx="6096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i="1" dirty="0" smtClean="0">
                <a:latin typeface="Arial" pitchFamily="34" charset="0"/>
                <a:cs typeface="Arial" pitchFamily="34" charset="0"/>
              </a:rPr>
              <a:t>pzh1</a:t>
            </a:r>
            <a:r>
              <a:rPr lang="el-GR" sz="800" b="1" i="1" dirty="0" smtClean="0">
                <a:latin typeface="Arial" pitchFamily="34" charset="0"/>
                <a:cs typeface="Arial" pitchFamily="34" charset="0"/>
              </a:rPr>
              <a:t>Δ</a:t>
            </a:r>
            <a:endParaRPr lang="sv-SE" sz="8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AutoShape 149"/>
          <p:cNvSpPr>
            <a:spLocks noChangeArrowheads="1"/>
          </p:cNvSpPr>
          <p:nvPr/>
        </p:nvSpPr>
        <p:spPr bwMode="auto">
          <a:xfrm>
            <a:off x="4166694" y="348484"/>
            <a:ext cx="1178473" cy="116927"/>
          </a:xfrm>
          <a:prstGeom prst="rtTriangle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sv-SE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 rot="16200000">
            <a:off x="2519578" y="4451200"/>
            <a:ext cx="6096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smtClean="0">
                <a:latin typeface="Arial" pitchFamily="34" charset="0"/>
                <a:cs typeface="Arial" pitchFamily="34" charset="0"/>
              </a:rPr>
              <a:t>DIC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 rot="16200000">
            <a:off x="2514323" y="3384400"/>
            <a:ext cx="6096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smtClean="0">
                <a:latin typeface="Arial" pitchFamily="34" charset="0"/>
                <a:cs typeface="Arial" pitchFamily="34" charset="0"/>
              </a:rPr>
              <a:t>DAPI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0" y="228600"/>
            <a:ext cx="2987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smtClean="0">
                <a:latin typeface="Arial" pitchFamily="34" charset="0"/>
                <a:cs typeface="Arial" pitchFamily="34" charset="0"/>
              </a:rPr>
              <a:t>A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3524250" y="247650"/>
            <a:ext cx="2987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smtClean="0">
                <a:latin typeface="Arial" pitchFamily="34" charset="0"/>
                <a:cs typeface="Arial" pitchFamily="34" charset="0"/>
              </a:rPr>
              <a:t>B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0" y="2790825"/>
            <a:ext cx="2987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smtClean="0">
                <a:latin typeface="Arial" pitchFamily="34" charset="0"/>
                <a:cs typeface="Arial" pitchFamily="34" charset="0"/>
              </a:rPr>
              <a:t>C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2568572" y="2606966"/>
            <a:ext cx="2987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smtClean="0">
                <a:latin typeface="Arial" pitchFamily="34" charset="0"/>
                <a:cs typeface="Arial" pitchFamily="34" charset="0"/>
              </a:rPr>
              <a:t>D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Left Bracket 48"/>
          <p:cNvSpPr/>
          <p:nvPr/>
        </p:nvSpPr>
        <p:spPr>
          <a:xfrm rot="10800000">
            <a:off x="3248025" y="466725"/>
            <a:ext cx="114300" cy="17907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TextBox 49"/>
          <p:cNvSpPr txBox="1"/>
          <p:nvPr/>
        </p:nvSpPr>
        <p:spPr>
          <a:xfrm rot="5400000">
            <a:off x="3176696" y="1258940"/>
            <a:ext cx="6096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smtClean="0">
                <a:latin typeface="Arial" pitchFamily="34" charset="0"/>
                <a:cs typeface="Arial" pitchFamily="34" charset="0"/>
              </a:rPr>
              <a:t>G418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51" name="Picture 9"/>
          <p:cNvPicPr>
            <a:picLocks noChangeAspect="1" noChangeArrowheads="1"/>
          </p:cNvPicPr>
          <p:nvPr/>
        </p:nvPicPr>
        <p:blipFill>
          <a:blip r:embed="rId15" cstate="print">
            <a:grayscl/>
            <a:lum bright="47000" contrast="77000"/>
          </a:blip>
          <a:srcRect/>
          <a:stretch>
            <a:fillRect/>
          </a:stretch>
        </p:blipFill>
        <p:spPr bwMode="auto">
          <a:xfrm>
            <a:off x="322263" y="5678304"/>
            <a:ext cx="1182687" cy="901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2" name="Picture 10"/>
          <p:cNvPicPr>
            <a:picLocks noChangeAspect="1" noChangeArrowheads="1"/>
          </p:cNvPicPr>
          <p:nvPr/>
        </p:nvPicPr>
        <p:blipFill>
          <a:blip r:embed="rId16" cstate="print">
            <a:grayscl/>
            <a:lum bright="47000" contrast="77000"/>
          </a:blip>
          <a:srcRect/>
          <a:stretch>
            <a:fillRect/>
          </a:stretch>
        </p:blipFill>
        <p:spPr bwMode="auto">
          <a:xfrm>
            <a:off x="322263" y="6616453"/>
            <a:ext cx="1182687" cy="901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3" name="TextBox 52"/>
          <p:cNvSpPr txBox="1"/>
          <p:nvPr/>
        </p:nvSpPr>
        <p:spPr>
          <a:xfrm>
            <a:off x="1493880" y="5717192"/>
            <a:ext cx="762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Contro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1493880" y="6014075"/>
            <a:ext cx="9429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LiCl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 4 </a:t>
            </a:r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mM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1493880" y="6310251"/>
            <a:ext cx="999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LiCl+ 0.6 M </a:t>
            </a:r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KCl</a:t>
            </a:r>
            <a:endParaRPr lang="sv-SE" sz="800" b="1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1493880" y="6629613"/>
            <a:ext cx="762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Contro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1493880" y="6962122"/>
            <a:ext cx="9429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LiCl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 4 </a:t>
            </a:r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mM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 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1493880" y="7284027"/>
            <a:ext cx="999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LiCl+ 0.6 M </a:t>
            </a:r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KCl</a:t>
            </a:r>
            <a:endParaRPr lang="sv-SE" sz="800" b="1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 rot="16200000">
            <a:off x="-117484" y="6950457"/>
            <a:ext cx="6096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i="1" dirty="0" smtClean="0">
                <a:latin typeface="Arial" pitchFamily="34" charset="0"/>
                <a:cs typeface="Arial" pitchFamily="34" charset="0"/>
              </a:rPr>
              <a:t>sod2</a:t>
            </a:r>
            <a:r>
              <a:rPr lang="el-GR" sz="800" b="1" i="1" dirty="0" smtClean="0">
                <a:latin typeface="Arial" pitchFamily="34" charset="0"/>
                <a:cs typeface="Arial" pitchFamily="34" charset="0"/>
              </a:rPr>
              <a:t>Δ</a:t>
            </a:r>
            <a:endParaRPr lang="sv-SE" sz="8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 rot="16200000">
            <a:off x="-117484" y="6034077"/>
            <a:ext cx="6096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i="1" dirty="0" smtClean="0">
                <a:latin typeface="Arial" pitchFamily="34" charset="0"/>
                <a:cs typeface="Arial" pitchFamily="34" charset="0"/>
              </a:rPr>
              <a:t>hal4</a:t>
            </a:r>
            <a:r>
              <a:rPr lang="el-GR" sz="800" b="1" i="1" dirty="0" smtClean="0">
                <a:latin typeface="Arial" pitchFamily="34" charset="0"/>
                <a:cs typeface="Arial" pitchFamily="34" charset="0"/>
              </a:rPr>
              <a:t>Δ</a:t>
            </a:r>
            <a:endParaRPr lang="sv-SE" sz="800" b="1" i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61" name="Picture 2"/>
          <p:cNvPicPr>
            <a:picLocks noChangeAspect="1" noChangeArrowheads="1"/>
          </p:cNvPicPr>
          <p:nvPr/>
        </p:nvPicPr>
        <p:blipFill>
          <a:blip r:embed="rId17" cstate="print"/>
          <a:srcRect r="19310"/>
          <a:stretch>
            <a:fillRect/>
          </a:stretch>
        </p:blipFill>
        <p:spPr bwMode="auto">
          <a:xfrm>
            <a:off x="315913" y="4729163"/>
            <a:ext cx="1189037" cy="9001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2" name="TextBox 61"/>
          <p:cNvSpPr txBox="1"/>
          <p:nvPr/>
        </p:nvSpPr>
        <p:spPr>
          <a:xfrm>
            <a:off x="1503405" y="4772238"/>
            <a:ext cx="762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Contro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1493880" y="5038072"/>
            <a:ext cx="9429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LiCl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 4 </a:t>
            </a:r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mM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1503404" y="5359977"/>
            <a:ext cx="9174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LiCl+ 0.6M </a:t>
            </a:r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KCl</a:t>
            </a:r>
            <a:endParaRPr lang="sv-SE" sz="800" b="1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 rot="16200000">
            <a:off x="-117485" y="5102607"/>
            <a:ext cx="6096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i="1" dirty="0" smtClean="0">
                <a:latin typeface="Arial" panose="020B0604020202020204" pitchFamily="34" charset="0"/>
                <a:cs typeface="Arial" pitchFamily="34" charset="0"/>
              </a:rPr>
              <a:t>wt</a:t>
            </a:r>
            <a:endParaRPr lang="sv-SE" sz="8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AutoShape 149"/>
          <p:cNvSpPr>
            <a:spLocks noChangeArrowheads="1"/>
          </p:cNvSpPr>
          <p:nvPr/>
        </p:nvSpPr>
        <p:spPr bwMode="auto">
          <a:xfrm>
            <a:off x="312243" y="4524376"/>
            <a:ext cx="1183182" cy="153624"/>
          </a:xfrm>
          <a:prstGeom prst="rtTriangle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sv-SE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0" y="4238625"/>
            <a:ext cx="2987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smtClean="0">
                <a:latin typeface="Arial" pitchFamily="34" charset="0"/>
                <a:cs typeface="Arial" pitchFamily="34" charset="0"/>
              </a:rPr>
              <a:t>E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0" y="-1"/>
            <a:ext cx="1219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sv-S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le</a:t>
            </a:r>
            <a:r>
              <a:rPr lang="sv-S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3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533790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90</Words>
  <Application>Microsoft Office PowerPoint</Application>
  <PresentationFormat>On-screen Show (4:3)</PresentationFormat>
  <Paragraphs>4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Gothenburg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Patrick Alao</dc:creator>
  <cp:lastModifiedBy>John Patrick Alao</cp:lastModifiedBy>
  <cp:revision>3</cp:revision>
  <dcterms:created xsi:type="dcterms:W3CDTF">2014-10-09T11:14:07Z</dcterms:created>
  <dcterms:modified xsi:type="dcterms:W3CDTF">2014-11-22T20:37:18Z</dcterms:modified>
</cp:coreProperties>
</file>